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6858000" cy="9144000" type="screen4x3"/>
  <p:notesSz cx="6669088" cy="99187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50" d="100"/>
          <a:sy n="50" d="100"/>
        </p:scale>
        <p:origin x="-2084" y="-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5935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5935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r">
              <a:defRPr sz="1200"/>
            </a:lvl1pPr>
          </a:lstStyle>
          <a:p>
            <a:fld id="{8FD763C2-9B07-4E2D-A44E-5945A634F606}" type="datetimeFigureOut">
              <a:rPr lang="en-US" smtClean="0"/>
              <a:t>10/28/201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3" rIns="91425" bIns="45713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909" y="4711383"/>
            <a:ext cx="5335270" cy="4463415"/>
          </a:xfrm>
          <a:prstGeom prst="rect">
            <a:avLst/>
          </a:prstGeom>
        </p:spPr>
        <p:txBody>
          <a:bodyPr vert="horz" lIns="91425" tIns="45713" rIns="91425" bIns="45713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1045"/>
            <a:ext cx="2889938" cy="495935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607" y="9421045"/>
            <a:ext cx="2889938" cy="495935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r">
              <a:defRPr sz="1200"/>
            </a:lvl1pPr>
          </a:lstStyle>
          <a:p>
            <a:fld id="{8F869E18-A33E-4335-B6E3-05BA55C6C78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08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39925" y="744538"/>
            <a:ext cx="2789238" cy="3719512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3F3494-9070-482D-8989-3C13B5F95F48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834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4815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2434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2315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6919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898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8613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3400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2681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2542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6909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6179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7700C-194F-4844-8076-851562658E2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28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50AFE-B366-4B0A-8F15-D955E20F51B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1189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425" y="4016566"/>
            <a:ext cx="3434982" cy="1596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935" y="2226831"/>
            <a:ext cx="3412472" cy="158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9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3" t="6736" r="17485" b="13890"/>
          <a:stretch/>
        </p:blipFill>
        <p:spPr bwMode="auto">
          <a:xfrm>
            <a:off x="2704459" y="4283932"/>
            <a:ext cx="1012573" cy="5040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1" name="Tabelle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3909721"/>
              </p:ext>
            </p:extLst>
          </p:nvPr>
        </p:nvGraphicFramePr>
        <p:xfrm>
          <a:off x="853749" y="272661"/>
          <a:ext cx="2647259" cy="153533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72073"/>
                <a:gridCol w="469595"/>
                <a:gridCol w="418849"/>
                <a:gridCol w="209425"/>
                <a:gridCol w="488658"/>
                <a:gridCol w="488659"/>
              </a:tblGrid>
              <a:tr h="436359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Embryo             </a:t>
                      </a:r>
                      <a:r>
                        <a:rPr lang="de-DE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4 </a:t>
                      </a:r>
                      <a:r>
                        <a:rPr lang="de-DE" sz="1200" b="1" i="0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rvae</a:t>
                      </a:r>
                      <a:r>
                        <a:rPr lang="de-DE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endParaRPr lang="de-DE" sz="1200" b="1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200" b="1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200" b="1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6306">
                <a:tc>
                  <a:txBody>
                    <a:bodyPr/>
                    <a:lstStyle/>
                    <a:p>
                      <a:pPr algn="ctr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3876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9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9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4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0822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9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0822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3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43982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/PL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188640" y="5734620"/>
            <a:ext cx="6336704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ilar changes of the triglyceride-to-phospholipid ratio and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att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composition of phosphatidylcholine (PC) in dietary restricted L4 larvae (P</a:t>
            </a:r>
            <a:r>
              <a:rPr lang="en-GB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) compared to embryos (F</a:t>
            </a:r>
            <a:r>
              <a:rPr lang="en-GB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) obtained from dietary restricted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rm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distributio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t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acylglycerid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AG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atidylethanolam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E), and phosphatidylcholine (PC) content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 libit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d (AL) and dietary restricted (DR) L4 larvae compared t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bryos obtain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from AL and DR adult worms. The resulting TAG-to-PL (PC+PE) ratios are also shown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 the mean of two independent experiments. Lipid analyses of L4 larvae and embryos were performed by thin layer chromatography (TLC) and mass spectroscopy, respectively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anges of fatty acid composition 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 in DR versus AL L4 larvae. Changes 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ualized by red and blue colors for increasing and decreasing, respectively, species amounts as percent within PC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 the mean of two independent experiment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B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ble bonds; 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pid speci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hanges of fatty acid composition 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mbryos (F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) DR obtain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from AL and DR adult worm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). Changes 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ualized by red and blue colors for increasing and decreasing, respectively, species amounts as percent within PC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 the mean of two independent experiment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B, doubl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n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i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95899" y="107504"/>
            <a:ext cx="648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/>
              <a:t>A</a:t>
            </a:r>
            <a:endParaRPr lang="de-DE" sz="24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173389" y="2084864"/>
            <a:ext cx="648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73389" y="3783439"/>
            <a:ext cx="648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C</a:t>
            </a:r>
          </a:p>
        </p:txBody>
      </p:sp>
      <p:pic>
        <p:nvPicPr>
          <p:cNvPr id="12" name="Picture 9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3" t="6736" r="17485" b="13890"/>
          <a:stretch/>
        </p:blipFill>
        <p:spPr bwMode="auto">
          <a:xfrm>
            <a:off x="2704459" y="2483768"/>
            <a:ext cx="1012573" cy="5040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98308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3</Words>
  <Application>Microsoft Office PowerPoint</Application>
  <PresentationFormat>Bildschirmpräsentation (4:3)</PresentationFormat>
  <Paragraphs>33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1_Larissa</vt:lpstr>
      <vt:lpstr>PowerPoint-Prä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lapper</dc:creator>
  <cp:lastModifiedBy>Frank</cp:lastModifiedBy>
  <cp:revision>26</cp:revision>
  <cp:lastPrinted>2015-10-28T10:07:30Z</cp:lastPrinted>
  <dcterms:created xsi:type="dcterms:W3CDTF">2015-07-09T09:06:32Z</dcterms:created>
  <dcterms:modified xsi:type="dcterms:W3CDTF">2015-10-28T16:12:28Z</dcterms:modified>
</cp:coreProperties>
</file>